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1pPr>
    <a:lvl2pPr marL="457001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2pPr>
    <a:lvl3pPr marL="914002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3pPr>
    <a:lvl4pPr marL="1371003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4pPr>
    <a:lvl5pPr marL="1828004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5pPr>
    <a:lvl6pPr marL="2285005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6pPr>
    <a:lvl7pPr marL="2742005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7pPr>
    <a:lvl8pPr marL="3199006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8pPr>
    <a:lvl9pPr marL="3656007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佑 佐藤" initials="佑" lastIdx="1" clrIdx="0">
    <p:extLst>
      <p:ext uri="{19B8F6BF-5375-455C-9EA6-DF929625EA0E}">
        <p15:presenceInfo xmlns:p15="http://schemas.microsoft.com/office/powerpoint/2012/main" userId="745bc0272a60672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淡色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47"/>
    <p:restoredTop sz="99659" autoAdjust="0"/>
  </p:normalViewPr>
  <p:slideViewPr>
    <p:cSldViewPr snapToGrid="0" snapToObjects="1">
      <p:cViewPr varScale="1">
        <p:scale>
          <a:sx n="81" d="100"/>
          <a:sy n="81" d="100"/>
        </p:scale>
        <p:origin x="3320" y="2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Book4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Book4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Book4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Book4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Book4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Book4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>
                <a:solidFill>
                  <a:schemeClr val="tx1"/>
                </a:solidFill>
              </a:rPr>
              <a:t>LP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9525">
              <a:solidFill>
                <a:sysClr val="windowText" lastClr="000000">
                  <a:lumMod val="95000"/>
                  <a:lumOff val="5000"/>
                </a:sys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 w="9525">
                <a:solidFill>
                  <a:sysClr val="windowText" lastClr="000000">
                    <a:lumMod val="95000"/>
                    <a:lumOff val="5000"/>
                  </a:sys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792-D54D-83C2-407882FA332A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/>
              </a:solidFill>
              <a:ln w="6350">
                <a:solidFill>
                  <a:sysClr val="windowText" lastClr="000000">
                    <a:lumMod val="95000"/>
                    <a:lumOff val="5000"/>
                  </a:sys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792-D54D-83C2-407882FA332A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1:$B$2</c:f>
              <c:strCache>
                <c:ptCount val="2"/>
                <c:pt idx="0">
                  <c:v>U</c:v>
                </c:pt>
                <c:pt idx="1">
                  <c:v>D</c:v>
                </c:pt>
              </c:strCache>
            </c:strRef>
          </c:cat>
          <c:val>
            <c:numRef>
              <c:f>Sheet1!$C$1:$C$2</c:f>
              <c:numCache>
                <c:formatCode>0.0</c:formatCode>
                <c:ptCount val="2"/>
                <c:pt idx="0">
                  <c:v>1</c:v>
                </c:pt>
                <c:pt idx="1">
                  <c:v>46.823688725546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792-D54D-83C2-407882FA33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6704"/>
        <c:axId val="-19755760"/>
      </c:barChart>
      <c:catAx>
        <c:axId val="8272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9755760"/>
        <c:crosses val="autoZero"/>
        <c:auto val="0"/>
        <c:lblAlgn val="ctr"/>
        <c:lblOffset val="100"/>
        <c:noMultiLvlLbl val="0"/>
      </c:catAx>
      <c:valAx>
        <c:axId val="-19755760"/>
        <c:scaling>
          <c:orientation val="minMax"/>
          <c:max val="5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726704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>
                <a:solidFill>
                  <a:schemeClr val="tx1"/>
                </a:solidFill>
              </a:rPr>
              <a:t>PPARG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D66-A644-8A87-1A7402A89484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D66-A644-8A87-1A7402A89484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4:$B$5</c:f>
              <c:strCache>
                <c:ptCount val="2"/>
                <c:pt idx="0">
                  <c:v>U</c:v>
                </c:pt>
                <c:pt idx="1">
                  <c:v>D</c:v>
                </c:pt>
              </c:strCache>
            </c:strRef>
          </c:cat>
          <c:val>
            <c:numRef>
              <c:f>Sheet1!$C$4:$C$5</c:f>
              <c:numCache>
                <c:formatCode>0.0</c:formatCode>
                <c:ptCount val="2"/>
                <c:pt idx="0">
                  <c:v>1</c:v>
                </c:pt>
                <c:pt idx="1">
                  <c:v>4.77294406841297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D66-A644-8A87-1A7402A894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6704"/>
        <c:axId val="-19755760"/>
      </c:barChart>
      <c:catAx>
        <c:axId val="8272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9755760"/>
        <c:crosses val="autoZero"/>
        <c:auto val="0"/>
        <c:lblAlgn val="ctr"/>
        <c:lblOffset val="100"/>
        <c:noMultiLvlLbl val="0"/>
      </c:catAx>
      <c:valAx>
        <c:axId val="-19755760"/>
        <c:scaling>
          <c:orientation val="minMax"/>
          <c:max val="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726704"/>
        <c:crosses val="autoZero"/>
        <c:crossBetween val="between"/>
        <c:majorUnit val="2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/>
              <a:t>ALPL</a:t>
            </a:r>
            <a:endParaRPr lang="ja-JP" altLang="en-US" sz="1200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62B-1E44-83B6-D9B41467B9A0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62B-1E44-83B6-D9B41467B9A0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7:$B$8</c:f>
              <c:strCache>
                <c:ptCount val="2"/>
                <c:pt idx="0">
                  <c:v>U</c:v>
                </c:pt>
                <c:pt idx="1">
                  <c:v>D</c:v>
                </c:pt>
              </c:strCache>
            </c:strRef>
          </c:cat>
          <c:val>
            <c:numRef>
              <c:f>Sheet1!$C$7:$C$8</c:f>
              <c:numCache>
                <c:formatCode>0.0</c:formatCode>
                <c:ptCount val="2"/>
                <c:pt idx="0">
                  <c:v>1</c:v>
                </c:pt>
                <c:pt idx="1">
                  <c:v>58.7102655376485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62B-1E44-83B6-D9B41467B9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6704"/>
        <c:axId val="-19755760"/>
      </c:barChart>
      <c:catAx>
        <c:axId val="8272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9755760"/>
        <c:crosses val="autoZero"/>
        <c:auto val="0"/>
        <c:lblAlgn val="ctr"/>
        <c:lblOffset val="100"/>
        <c:noMultiLvlLbl val="0"/>
      </c:catAx>
      <c:valAx>
        <c:axId val="-19755760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72670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/>
              <a:t>SPP1</a:t>
            </a:r>
            <a:endParaRPr lang="ja-JP" altLang="en-US" sz="1200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7FB-5145-A4F8-CE79CC972E51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7FB-5145-A4F8-CE79CC972E51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10:$B$11</c:f>
              <c:strCache>
                <c:ptCount val="2"/>
                <c:pt idx="0">
                  <c:v>U</c:v>
                </c:pt>
                <c:pt idx="1">
                  <c:v>D</c:v>
                </c:pt>
              </c:strCache>
            </c:strRef>
          </c:cat>
          <c:val>
            <c:numRef>
              <c:f>Sheet1!$C$10:$C$11</c:f>
              <c:numCache>
                <c:formatCode>0.0</c:formatCode>
                <c:ptCount val="2"/>
                <c:pt idx="0">
                  <c:v>1</c:v>
                </c:pt>
                <c:pt idx="1">
                  <c:v>101.40951128154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FB-5145-A4F8-CE79CC972E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6704"/>
        <c:axId val="-19755760"/>
      </c:barChart>
      <c:catAx>
        <c:axId val="8272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9755760"/>
        <c:crosses val="autoZero"/>
        <c:auto val="0"/>
        <c:lblAlgn val="ctr"/>
        <c:lblOffset val="100"/>
        <c:noMultiLvlLbl val="0"/>
      </c:catAx>
      <c:valAx>
        <c:axId val="-19755760"/>
        <c:scaling>
          <c:orientation val="minMax"/>
          <c:max val="15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72670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 dirty="0"/>
              <a:t>COL10A1</a:t>
            </a:r>
            <a:endParaRPr lang="ja-JP" altLang="en-US" sz="1200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DBA-9348-9B6F-1F8DAEAEB287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DBA-9348-9B6F-1F8DAEAEB287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13:$B$14</c:f>
              <c:strCache>
                <c:ptCount val="2"/>
                <c:pt idx="0">
                  <c:v>U</c:v>
                </c:pt>
                <c:pt idx="1">
                  <c:v>D</c:v>
                </c:pt>
              </c:strCache>
            </c:strRef>
          </c:cat>
          <c:val>
            <c:numRef>
              <c:f>Sheet1!$C$13:$C$14</c:f>
              <c:numCache>
                <c:formatCode>0.0</c:formatCode>
                <c:ptCount val="2"/>
                <c:pt idx="0">
                  <c:v>1</c:v>
                </c:pt>
                <c:pt idx="1">
                  <c:v>27.318159262491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DBA-9348-9B6F-1F8DAEAEB2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6704"/>
        <c:axId val="-19755760"/>
      </c:barChart>
      <c:catAx>
        <c:axId val="8272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9755760"/>
        <c:crosses val="autoZero"/>
        <c:auto val="0"/>
        <c:lblAlgn val="ctr"/>
        <c:lblOffset val="100"/>
        <c:noMultiLvlLbl val="0"/>
      </c:catAx>
      <c:valAx>
        <c:axId val="-19755760"/>
        <c:scaling>
          <c:orientation val="minMax"/>
          <c:max val="5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726704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/>
              <a:t>SOX9</a:t>
            </a:r>
            <a:endParaRPr lang="ja-JP" altLang="en-US" sz="1200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77E-3B47-8FB7-7386F0C8B04A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77E-3B47-8FB7-7386F0C8B04A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16:$B$17</c:f>
              <c:strCache>
                <c:ptCount val="2"/>
                <c:pt idx="0">
                  <c:v>U</c:v>
                </c:pt>
                <c:pt idx="1">
                  <c:v>D</c:v>
                </c:pt>
              </c:strCache>
            </c:strRef>
          </c:cat>
          <c:val>
            <c:numRef>
              <c:f>Sheet1!$C$16:$C$17</c:f>
              <c:numCache>
                <c:formatCode>0.0</c:formatCode>
                <c:ptCount val="2"/>
                <c:pt idx="0">
                  <c:v>1</c:v>
                </c:pt>
                <c:pt idx="1">
                  <c:v>9.63576097845507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77E-3B47-8FB7-7386F0C8B0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26704"/>
        <c:axId val="-19755760"/>
      </c:barChart>
      <c:catAx>
        <c:axId val="8272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19755760"/>
        <c:crosses val="autoZero"/>
        <c:auto val="0"/>
        <c:lblAlgn val="ctr"/>
        <c:lblOffset val="100"/>
        <c:noMultiLvlLbl val="0"/>
      </c:catAx>
      <c:valAx>
        <c:axId val="-19755760"/>
        <c:scaling>
          <c:orientation val="minMax"/>
          <c:max val="1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72670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ED0B24-FFC1-D544-BD29-6D7A5590AD37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C06FF3-DD2A-674E-BEAC-D7625FC218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484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1pPr>
    <a:lvl2pPr marL="457001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2pPr>
    <a:lvl3pPr marL="914002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3pPr>
    <a:lvl4pPr marL="1371003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4pPr>
    <a:lvl5pPr marL="1828004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5pPr>
    <a:lvl6pPr marL="2285005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6pPr>
    <a:lvl7pPr marL="2742005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7pPr>
    <a:lvl8pPr marL="3199006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8pPr>
    <a:lvl9pPr marL="3656007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1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907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433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682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923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621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973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39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8381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94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09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325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74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chart" Target="../charts/chart5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chart" Target="../charts/chart4.xml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chart" Target="../charts/chart3.xml"/><Relationship Id="rId5" Type="http://schemas.openxmlformats.org/officeDocument/2006/relationships/image" Target="../media/image4.png"/><Relationship Id="rId10" Type="http://schemas.openxmlformats.org/officeDocument/2006/relationships/chart" Target="../charts/chart2.xml"/><Relationship Id="rId4" Type="http://schemas.openxmlformats.org/officeDocument/2006/relationships/image" Target="../media/image3.png"/><Relationship Id="rId9" Type="http://schemas.openxmlformats.org/officeDocument/2006/relationships/chart" Target="../charts/chart1.xml"/><Relationship Id="rId1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F93774E-3B83-1641-B06E-3327C9A33AF6}"/>
              </a:ext>
            </a:extLst>
          </p:cNvPr>
          <p:cNvSpPr txBox="1"/>
          <p:nvPr/>
        </p:nvSpPr>
        <p:spPr>
          <a:xfrm>
            <a:off x="143934" y="186267"/>
            <a:ext cx="785793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1</a:t>
            </a:r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F4BFCDD-8CEE-5948-9D3B-170C9C1A532F}"/>
              </a:ext>
            </a:extLst>
          </p:cNvPr>
          <p:cNvSpPr txBox="1"/>
          <p:nvPr/>
        </p:nvSpPr>
        <p:spPr>
          <a:xfrm>
            <a:off x="313267" y="762000"/>
            <a:ext cx="29527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C784196-B7DB-1045-86F5-279724B49B12}"/>
              </a:ext>
            </a:extLst>
          </p:cNvPr>
          <p:cNvSpPr txBox="1"/>
          <p:nvPr/>
        </p:nvSpPr>
        <p:spPr>
          <a:xfrm>
            <a:off x="2484151" y="762000"/>
            <a:ext cx="30649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8D91881-F89F-F543-9463-A07170203BF4}"/>
              </a:ext>
            </a:extLst>
          </p:cNvPr>
          <p:cNvSpPr txBox="1"/>
          <p:nvPr/>
        </p:nvSpPr>
        <p:spPr>
          <a:xfrm>
            <a:off x="313267" y="4207928"/>
            <a:ext cx="282450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C8351D4-3511-2E41-AD98-78A75835B8F2}"/>
              </a:ext>
            </a:extLst>
          </p:cNvPr>
          <p:cNvSpPr txBox="1"/>
          <p:nvPr/>
        </p:nvSpPr>
        <p:spPr>
          <a:xfrm>
            <a:off x="814089" y="4465345"/>
            <a:ext cx="1428020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Osteogenesis</a:t>
            </a:r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FE75B06-BB81-CD4B-9D65-87E2E0200C44}"/>
              </a:ext>
            </a:extLst>
          </p:cNvPr>
          <p:cNvSpPr txBox="1"/>
          <p:nvPr/>
        </p:nvSpPr>
        <p:spPr>
          <a:xfrm>
            <a:off x="2936101" y="4465345"/>
            <a:ext cx="142827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Adipogenesis</a:t>
            </a:r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97D115D-D806-374F-A09F-C28DA8EBBCC2}"/>
              </a:ext>
            </a:extLst>
          </p:cNvPr>
          <p:cNvSpPr txBox="1"/>
          <p:nvPr/>
        </p:nvSpPr>
        <p:spPr>
          <a:xfrm>
            <a:off x="4852399" y="4465345"/>
            <a:ext cx="168584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Chondrogenesis</a:t>
            </a:r>
            <a:endParaRPr kumimoji="1" lang="ja-JP" altLang="en-US"/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B09A23C9-8D16-A647-823B-3FEF6F49DD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39460" y="1539464"/>
            <a:ext cx="2474815" cy="1856112"/>
          </a:xfrm>
          <a:prstGeom prst="rect">
            <a:avLst/>
          </a:prstGeom>
        </p:spPr>
      </p:pic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E6F8667A-047A-8644-809D-A8C3F6A6B2E1}"/>
              </a:ext>
            </a:extLst>
          </p:cNvPr>
          <p:cNvCxnSpPr/>
          <p:nvPr/>
        </p:nvCxnSpPr>
        <p:spPr>
          <a:xfrm>
            <a:off x="1990725" y="3603625"/>
            <a:ext cx="250825" cy="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図 2">
            <a:extLst>
              <a:ext uri="{FF2B5EF4-FFF2-40B4-BE49-F238E27FC236}">
                <a16:creationId xmlns:a16="http://schemas.microsoft.com/office/drawing/2014/main" id="{55B55293-052E-014C-96FC-BC86296D21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38588" y="2611934"/>
            <a:ext cx="1369270" cy="143385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F66D1EC-BA74-2848-8106-F139F0495C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63610" y="2592557"/>
            <a:ext cx="1388647" cy="1453235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23B691D8-4E03-DB4B-AE25-B01B386320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69627" y="1140878"/>
            <a:ext cx="1369269" cy="1453233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6F65FC9F-FA3B-4F4F-9B5D-4F8D4DC4C8F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09878" y="1160253"/>
            <a:ext cx="1375728" cy="1433858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1DC24289-A5F9-BE49-A816-F9137AB922E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56587" y="1160253"/>
            <a:ext cx="1369270" cy="1433858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28FAC077-174F-9E46-8D79-BEFC6E9DA7C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74474" y="2670064"/>
            <a:ext cx="1408022" cy="1375728"/>
          </a:xfrm>
          <a:prstGeom prst="rect">
            <a:avLst/>
          </a:prstGeom>
        </p:spPr>
      </p:pic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A5CA86FD-ECF9-774F-B46A-2ED435B942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1610527"/>
              </p:ext>
            </p:extLst>
          </p:nvPr>
        </p:nvGraphicFramePr>
        <p:xfrm>
          <a:off x="2637788" y="5016132"/>
          <a:ext cx="198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F3DE4AC6-E00D-2742-91FC-406BFE8822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5290808"/>
              </p:ext>
            </p:extLst>
          </p:nvPr>
        </p:nvGraphicFramePr>
        <p:xfrm>
          <a:off x="2714238" y="6680350"/>
          <a:ext cx="187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DCE53D88-6D63-7B45-9499-687CF0909A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5904849"/>
              </p:ext>
            </p:extLst>
          </p:nvPr>
        </p:nvGraphicFramePr>
        <p:xfrm>
          <a:off x="570254" y="5016132"/>
          <a:ext cx="198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6290D667-1A50-4640-963F-92126935CE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4959400"/>
              </p:ext>
            </p:extLst>
          </p:nvPr>
        </p:nvGraphicFramePr>
        <p:xfrm>
          <a:off x="570254" y="6680350"/>
          <a:ext cx="198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12F088E1-EE35-BE4B-912A-C64331E880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433211"/>
              </p:ext>
            </p:extLst>
          </p:nvPr>
        </p:nvGraphicFramePr>
        <p:xfrm>
          <a:off x="4705322" y="5016132"/>
          <a:ext cx="198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0B68289F-12CD-E244-970D-622E328049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4731875"/>
              </p:ext>
            </p:extLst>
          </p:nvPr>
        </p:nvGraphicFramePr>
        <p:xfrm>
          <a:off x="4705322" y="6680350"/>
          <a:ext cx="198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5827A2F-18F6-5341-926E-604F56817127}"/>
              </a:ext>
            </a:extLst>
          </p:cNvPr>
          <p:cNvSpPr txBox="1"/>
          <p:nvPr/>
        </p:nvSpPr>
        <p:spPr>
          <a:xfrm rot="16200000">
            <a:off x="-703654" y="6499255"/>
            <a:ext cx="2265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Relative expressions of mRNA</a:t>
            </a:r>
            <a:endParaRPr lang="ja-JP" altLang="en-US" sz="12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0B2A01A-C1AC-134C-A82D-EFDA9410698D}"/>
              </a:ext>
            </a:extLst>
          </p:cNvPr>
          <p:cNvSpPr txBox="1"/>
          <p:nvPr/>
        </p:nvSpPr>
        <p:spPr>
          <a:xfrm>
            <a:off x="5188429" y="8354028"/>
            <a:ext cx="13734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U=undifferentiated</a:t>
            </a:r>
          </a:p>
          <a:p>
            <a:r>
              <a:rPr lang="en-US" altLang="ja-JP" sz="1200" dirty="0"/>
              <a:t>D=differentiated 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06162871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0712</TotalTime>
  <Words>25</Words>
  <Application>Microsoft Macintosh PowerPoint</Application>
  <PresentationFormat>A4 210 x 297 mm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佑</dc:creator>
  <cp:lastModifiedBy>佑 佐藤</cp:lastModifiedBy>
  <cp:revision>310</cp:revision>
  <cp:lastPrinted>2020-06-01T08:11:19Z</cp:lastPrinted>
  <dcterms:created xsi:type="dcterms:W3CDTF">2019-04-02T03:50:26Z</dcterms:created>
  <dcterms:modified xsi:type="dcterms:W3CDTF">2020-06-06T07:40:36Z</dcterms:modified>
</cp:coreProperties>
</file>